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15119350" cy="21383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735">
          <p15:clr>
            <a:srgbClr val="A4A3A4"/>
          </p15:clr>
        </p15:guide>
        <p15:guide id="2" pos="476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CFB7"/>
    <a:srgbClr val="DAB48E"/>
    <a:srgbClr val="FFEBAB"/>
    <a:srgbClr val="E1E1FF"/>
    <a:srgbClr val="CCCCFF"/>
    <a:srgbClr val="CC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>
        <p:scale>
          <a:sx n="112" d="100"/>
          <a:sy n="112" d="100"/>
        </p:scale>
        <p:origin x="-1445" y="-1706"/>
      </p:cViewPr>
      <p:guideLst>
        <p:guide orient="horz" pos="6735"/>
        <p:guide pos="47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33951" y="3499590"/>
            <a:ext cx="12851448" cy="7444669"/>
          </a:xfrm>
        </p:spPr>
        <p:txBody>
          <a:bodyPr anchor="b"/>
          <a:lstStyle>
            <a:lvl1pPr algn="ctr">
              <a:defRPr sz="9921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89919" y="11231355"/>
            <a:ext cx="11339513" cy="5162758"/>
          </a:xfrm>
        </p:spPr>
        <p:txBody>
          <a:bodyPr/>
          <a:lstStyle>
            <a:lvl1pPr marL="0" indent="0" algn="ctr">
              <a:buNone/>
              <a:defRPr sz="3968"/>
            </a:lvl1pPr>
            <a:lvl2pPr marL="755980" indent="0" algn="ctr">
              <a:buNone/>
              <a:defRPr sz="3307"/>
            </a:lvl2pPr>
            <a:lvl3pPr marL="1511960" indent="0" algn="ctr">
              <a:buNone/>
              <a:defRPr sz="2976"/>
            </a:lvl3pPr>
            <a:lvl4pPr marL="2267941" indent="0" algn="ctr">
              <a:buNone/>
              <a:defRPr sz="2646"/>
            </a:lvl4pPr>
            <a:lvl5pPr marL="3023921" indent="0" algn="ctr">
              <a:buNone/>
              <a:defRPr sz="2646"/>
            </a:lvl5pPr>
            <a:lvl6pPr marL="3779901" indent="0" algn="ctr">
              <a:buNone/>
              <a:defRPr sz="2646"/>
            </a:lvl6pPr>
            <a:lvl7pPr marL="4535881" indent="0" algn="ctr">
              <a:buNone/>
              <a:defRPr sz="2646"/>
            </a:lvl7pPr>
            <a:lvl8pPr marL="5291861" indent="0" algn="ctr">
              <a:buNone/>
              <a:defRPr sz="2646"/>
            </a:lvl8pPr>
            <a:lvl9pPr marL="6047842" indent="0" algn="ctr">
              <a:buNone/>
              <a:defRPr sz="2646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96314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8667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819786" y="1138480"/>
            <a:ext cx="3260110" cy="18121634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39456" y="1138480"/>
            <a:ext cx="9591338" cy="18121634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45852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22250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1582" y="5331063"/>
            <a:ext cx="13040439" cy="8894992"/>
          </a:xfrm>
        </p:spPr>
        <p:txBody>
          <a:bodyPr anchor="b"/>
          <a:lstStyle>
            <a:lvl1pPr>
              <a:defRPr sz="9921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1582" y="14310205"/>
            <a:ext cx="13040439" cy="4677666"/>
          </a:xfrm>
        </p:spPr>
        <p:txBody>
          <a:bodyPr/>
          <a:lstStyle>
            <a:lvl1pPr marL="0" indent="0">
              <a:buNone/>
              <a:defRPr sz="3968">
                <a:solidFill>
                  <a:schemeClr val="tx1"/>
                </a:solidFill>
              </a:defRPr>
            </a:lvl1pPr>
            <a:lvl2pPr marL="755980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2pPr>
            <a:lvl3pPr marL="1511960" indent="0">
              <a:buNone/>
              <a:defRPr sz="2976">
                <a:solidFill>
                  <a:schemeClr val="tx1">
                    <a:tint val="75000"/>
                  </a:schemeClr>
                </a:solidFill>
              </a:defRPr>
            </a:lvl3pPr>
            <a:lvl4pPr marL="226794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4pPr>
            <a:lvl5pPr marL="302392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5pPr>
            <a:lvl6pPr marL="377990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6pPr>
            <a:lvl7pPr marL="453588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7pPr>
            <a:lvl8pPr marL="529186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8pPr>
            <a:lvl9pPr marL="6047842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26291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39455" y="5692400"/>
            <a:ext cx="6425724" cy="1356771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54171" y="5692400"/>
            <a:ext cx="6425724" cy="1356771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9901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138485"/>
            <a:ext cx="13040439" cy="4133179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1426" y="5241960"/>
            <a:ext cx="6396193" cy="2569003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1426" y="7810963"/>
            <a:ext cx="6396193" cy="11488750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654172" y="5241960"/>
            <a:ext cx="6427693" cy="2569003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654172" y="7810963"/>
            <a:ext cx="6427693" cy="11488750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9769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625455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15613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25575"/>
            <a:ext cx="4876384" cy="4989513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27693" y="3078850"/>
            <a:ext cx="7654171" cy="15196234"/>
          </a:xfrm>
        </p:spPr>
        <p:txBody>
          <a:bodyPr/>
          <a:lstStyle>
            <a:lvl1pPr>
              <a:defRPr sz="5291"/>
            </a:lvl1pPr>
            <a:lvl2pPr>
              <a:defRPr sz="4630"/>
            </a:lvl2pPr>
            <a:lvl3pPr>
              <a:defRPr sz="3968"/>
            </a:lvl3pPr>
            <a:lvl4pPr>
              <a:defRPr sz="3307"/>
            </a:lvl4pPr>
            <a:lvl5pPr>
              <a:defRPr sz="3307"/>
            </a:lvl5pPr>
            <a:lvl6pPr>
              <a:defRPr sz="3307"/>
            </a:lvl6pPr>
            <a:lvl7pPr>
              <a:defRPr sz="3307"/>
            </a:lvl7pPr>
            <a:lvl8pPr>
              <a:defRPr sz="3307"/>
            </a:lvl8pPr>
            <a:lvl9pPr>
              <a:defRPr sz="3307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415088"/>
            <a:ext cx="4876384" cy="1188474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33702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25575"/>
            <a:ext cx="4876384" cy="4989513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27693" y="3078850"/>
            <a:ext cx="7654171" cy="15196234"/>
          </a:xfrm>
        </p:spPr>
        <p:txBody>
          <a:bodyPr anchor="t"/>
          <a:lstStyle>
            <a:lvl1pPr marL="0" indent="0">
              <a:buNone/>
              <a:defRPr sz="5291"/>
            </a:lvl1pPr>
            <a:lvl2pPr marL="755980" indent="0">
              <a:buNone/>
              <a:defRPr sz="4630"/>
            </a:lvl2pPr>
            <a:lvl3pPr marL="1511960" indent="0">
              <a:buNone/>
              <a:defRPr sz="3968"/>
            </a:lvl3pPr>
            <a:lvl4pPr marL="2267941" indent="0">
              <a:buNone/>
              <a:defRPr sz="3307"/>
            </a:lvl4pPr>
            <a:lvl5pPr marL="3023921" indent="0">
              <a:buNone/>
              <a:defRPr sz="3307"/>
            </a:lvl5pPr>
            <a:lvl6pPr marL="3779901" indent="0">
              <a:buNone/>
              <a:defRPr sz="3307"/>
            </a:lvl6pPr>
            <a:lvl7pPr marL="4535881" indent="0">
              <a:buNone/>
              <a:defRPr sz="3307"/>
            </a:lvl7pPr>
            <a:lvl8pPr marL="5291861" indent="0">
              <a:buNone/>
              <a:defRPr sz="3307"/>
            </a:lvl8pPr>
            <a:lvl9pPr marL="6047842" indent="0">
              <a:buNone/>
              <a:defRPr sz="3307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415088"/>
            <a:ext cx="4876384" cy="1188474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74602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39456" y="1138485"/>
            <a:ext cx="13040439" cy="413317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9456" y="5692400"/>
            <a:ext cx="13040439" cy="135677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39455" y="19819457"/>
            <a:ext cx="3401854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E6FBB-350B-41DC-B45A-54CEB7F7CF06}" type="datetimeFigureOut">
              <a:rPr lang="de-CH" smtClean="0"/>
              <a:t>16.12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08285" y="19819457"/>
            <a:ext cx="5102781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678041" y="19819457"/>
            <a:ext cx="3401854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C77FE-F90C-49EE-B6B3-0176EC28C70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43047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11960" rtl="0" eaLnBrk="1" latinLnBrk="0" hangingPunct="1">
        <a:lnSpc>
          <a:spcPct val="90000"/>
        </a:lnSpc>
        <a:spcBef>
          <a:spcPct val="0"/>
        </a:spcBef>
        <a:buNone/>
        <a:defRPr sz="72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7990" indent="-377990" algn="l" defTabSz="1511960" rtl="0" eaLnBrk="1" latinLnBrk="0" hangingPunct="1">
        <a:lnSpc>
          <a:spcPct val="90000"/>
        </a:lnSpc>
        <a:spcBef>
          <a:spcPts val="1654"/>
        </a:spcBef>
        <a:buFont typeface="Arial" panose="020B0604020202020204" pitchFamily="34" charset="0"/>
        <a:buChar char="•"/>
        <a:defRPr sz="4630" kern="1200">
          <a:solidFill>
            <a:schemeClr val="tx1"/>
          </a:solidFill>
          <a:latin typeface="+mn-lt"/>
          <a:ea typeface="+mn-ea"/>
          <a:cs typeface="+mn-cs"/>
        </a:defRPr>
      </a:lvl1pPr>
      <a:lvl2pPr marL="1133970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2pPr>
      <a:lvl3pPr marL="188995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3pPr>
      <a:lvl4pPr marL="264593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40191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415789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91387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66985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42583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5598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2pPr>
      <a:lvl3pPr marL="151196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3pPr>
      <a:lvl4pPr marL="226794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02392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377990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53588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29186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047842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EA201A1E-85E7-417E-AF04-0392B8741E2A}"/>
              </a:ext>
            </a:extLst>
          </p:cNvPr>
          <p:cNvSpPr txBox="1"/>
          <p:nvPr/>
        </p:nvSpPr>
        <p:spPr>
          <a:xfrm>
            <a:off x="1553102" y="818373"/>
            <a:ext cx="119739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CH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GB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omplete workflow of the methodology. Each of the six stages of the methodology includes one or more individual steps. Resources used are indicated (JC, John The Physician’s Commentary; DMM,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ioscorides</a:t>
            </a:r>
            <a:r>
              <a:rPr lang="en-GB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’ </a:t>
            </a:r>
            <a:r>
              <a:rPr lang="en-GB" sz="14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 Materia Medica</a:t>
            </a:r>
            <a:r>
              <a:rPr lang="en-GB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</a:t>
            </a:r>
            <a:r>
              <a:rPr lang="en-GB" sz="14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GB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otanical literature on DMM plants; MPNS, Kew’s Medicinal Plant Names Services; Herbal medicine and ethnobotanical literature; Human clinical trial literature; FW, Floristic works). See section 2 of the paper for full reference details to the resources.</a:t>
            </a:r>
            <a:endParaRPr lang="de-CH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7AB30B7D-E28F-8BCA-A720-E3030CCA62A3}"/>
              </a:ext>
            </a:extLst>
          </p:cNvPr>
          <p:cNvGrpSpPr/>
          <p:nvPr/>
        </p:nvGrpSpPr>
        <p:grpSpPr>
          <a:xfrm>
            <a:off x="2069379" y="2957747"/>
            <a:ext cx="11299021" cy="14024381"/>
            <a:chOff x="2113624" y="2957747"/>
            <a:chExt cx="11299021" cy="14024381"/>
          </a:xfrm>
        </p:grpSpPr>
        <p:grpSp>
          <p:nvGrpSpPr>
            <p:cNvPr id="192" name="Gruppieren 191">
              <a:extLst>
                <a:ext uri="{FF2B5EF4-FFF2-40B4-BE49-F238E27FC236}">
                  <a16:creationId xmlns:a16="http://schemas.microsoft.com/office/drawing/2014/main" id="{F2017F6D-A1FD-4A76-AE7B-03B2A07B11E9}"/>
                </a:ext>
              </a:extLst>
            </p:cNvPr>
            <p:cNvGrpSpPr/>
            <p:nvPr/>
          </p:nvGrpSpPr>
          <p:grpSpPr>
            <a:xfrm>
              <a:off x="2297268" y="2961985"/>
              <a:ext cx="4574275" cy="312557"/>
              <a:chOff x="1672148" y="1561546"/>
              <a:chExt cx="4574275" cy="312557"/>
            </a:xfrm>
          </p:grpSpPr>
          <p:sp>
            <p:nvSpPr>
              <p:cNvPr id="186" name="Textfeld 185">
                <a:extLst>
                  <a:ext uri="{FF2B5EF4-FFF2-40B4-BE49-F238E27FC236}">
                    <a16:creationId xmlns:a16="http://schemas.microsoft.com/office/drawing/2014/main" id="{35193BB5-A9FA-43C0-8B2D-976110C70688}"/>
                  </a:ext>
                </a:extLst>
              </p:cNvPr>
              <p:cNvSpPr txBox="1"/>
              <p:nvPr/>
            </p:nvSpPr>
            <p:spPr>
              <a:xfrm>
                <a:off x="1672148" y="1566326"/>
                <a:ext cx="13249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esources</a:t>
                </a:r>
              </a:p>
            </p:txBody>
          </p:sp>
          <p:sp>
            <p:nvSpPr>
              <p:cNvPr id="187" name="Textfeld 186">
                <a:extLst>
                  <a:ext uri="{FF2B5EF4-FFF2-40B4-BE49-F238E27FC236}">
                    <a16:creationId xmlns:a16="http://schemas.microsoft.com/office/drawing/2014/main" id="{7D6EC4B0-C8E0-4C88-A8C8-7D6BCC924A18}"/>
                  </a:ext>
                </a:extLst>
              </p:cNvPr>
              <p:cNvSpPr txBox="1"/>
              <p:nvPr/>
            </p:nvSpPr>
            <p:spPr>
              <a:xfrm>
                <a:off x="3097661" y="1563593"/>
                <a:ext cx="13249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ocess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eps</a:t>
                </a:r>
                <a:endParaRPr lang="de-CH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Textfeld 187">
                <a:extLst>
                  <a:ext uri="{FF2B5EF4-FFF2-40B4-BE49-F238E27FC236}">
                    <a16:creationId xmlns:a16="http://schemas.microsoft.com/office/drawing/2014/main" id="{508C9CD7-9E6B-4337-91E5-AD43145ECFF1}"/>
                  </a:ext>
                </a:extLst>
              </p:cNvPr>
              <p:cNvSpPr txBox="1"/>
              <p:nvPr/>
            </p:nvSpPr>
            <p:spPr>
              <a:xfrm>
                <a:off x="4921494" y="1561546"/>
                <a:ext cx="13249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Output</a:t>
                </a:r>
              </a:p>
            </p:txBody>
          </p:sp>
        </p:grpSp>
        <p:grpSp>
          <p:nvGrpSpPr>
            <p:cNvPr id="193" name="Gruppieren 192">
              <a:extLst>
                <a:ext uri="{FF2B5EF4-FFF2-40B4-BE49-F238E27FC236}">
                  <a16:creationId xmlns:a16="http://schemas.microsoft.com/office/drawing/2014/main" id="{04BE089B-36CA-4A70-825E-AA281E74657F}"/>
                </a:ext>
              </a:extLst>
            </p:cNvPr>
            <p:cNvGrpSpPr/>
            <p:nvPr/>
          </p:nvGrpSpPr>
          <p:grpSpPr>
            <a:xfrm>
              <a:off x="8719760" y="2957747"/>
              <a:ext cx="4574275" cy="312557"/>
              <a:chOff x="8977876" y="1561546"/>
              <a:chExt cx="4574275" cy="312557"/>
            </a:xfrm>
          </p:grpSpPr>
          <p:sp>
            <p:nvSpPr>
              <p:cNvPr id="189" name="Textfeld 188">
                <a:extLst>
                  <a:ext uri="{FF2B5EF4-FFF2-40B4-BE49-F238E27FC236}">
                    <a16:creationId xmlns:a16="http://schemas.microsoft.com/office/drawing/2014/main" id="{8DBE3983-A9C8-457A-8452-79BEA858817D}"/>
                  </a:ext>
                </a:extLst>
              </p:cNvPr>
              <p:cNvSpPr txBox="1"/>
              <p:nvPr/>
            </p:nvSpPr>
            <p:spPr>
              <a:xfrm>
                <a:off x="8977876" y="1566326"/>
                <a:ext cx="13249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esources</a:t>
                </a:r>
              </a:p>
            </p:txBody>
          </p:sp>
          <p:sp>
            <p:nvSpPr>
              <p:cNvPr id="190" name="Textfeld 189">
                <a:extLst>
                  <a:ext uri="{FF2B5EF4-FFF2-40B4-BE49-F238E27FC236}">
                    <a16:creationId xmlns:a16="http://schemas.microsoft.com/office/drawing/2014/main" id="{FA86AA86-F788-4F6F-8791-F22533F79AEA}"/>
                  </a:ext>
                </a:extLst>
              </p:cNvPr>
              <p:cNvSpPr txBox="1"/>
              <p:nvPr/>
            </p:nvSpPr>
            <p:spPr>
              <a:xfrm>
                <a:off x="10403389" y="1563593"/>
                <a:ext cx="13249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ocess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eps</a:t>
                </a:r>
                <a:endParaRPr lang="de-CH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Textfeld 190">
                <a:extLst>
                  <a:ext uri="{FF2B5EF4-FFF2-40B4-BE49-F238E27FC236}">
                    <a16:creationId xmlns:a16="http://schemas.microsoft.com/office/drawing/2014/main" id="{485FD9FD-7FAB-4A91-A7DE-3512B56A82C5}"/>
                  </a:ext>
                </a:extLst>
              </p:cNvPr>
              <p:cNvSpPr txBox="1"/>
              <p:nvPr/>
            </p:nvSpPr>
            <p:spPr>
              <a:xfrm>
                <a:off x="12227222" y="1561546"/>
                <a:ext cx="13249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Output</a:t>
                </a:r>
              </a:p>
            </p:txBody>
          </p:sp>
        </p:grpSp>
        <p:grpSp>
          <p:nvGrpSpPr>
            <p:cNvPr id="199" name="Gruppieren 198">
              <a:extLst>
                <a:ext uri="{FF2B5EF4-FFF2-40B4-BE49-F238E27FC236}">
                  <a16:creationId xmlns:a16="http://schemas.microsoft.com/office/drawing/2014/main" id="{0F001944-4402-4E56-8CFD-548DEAC0FF78}"/>
                </a:ext>
              </a:extLst>
            </p:cNvPr>
            <p:cNvGrpSpPr/>
            <p:nvPr/>
          </p:nvGrpSpPr>
          <p:grpSpPr>
            <a:xfrm>
              <a:off x="2113624" y="3573713"/>
              <a:ext cx="5754820" cy="6639916"/>
              <a:chOff x="678879" y="1754174"/>
              <a:chExt cx="5754820" cy="6639916"/>
            </a:xfrm>
          </p:grpSpPr>
          <p:sp>
            <p:nvSpPr>
              <p:cNvPr id="36" name="Flussdiagramm: Lochstreifen 8">
                <a:extLst>
                  <a:ext uri="{FF2B5EF4-FFF2-40B4-BE49-F238E27FC236}">
                    <a16:creationId xmlns:a16="http://schemas.microsoft.com/office/drawing/2014/main" id="{3423433D-5A01-43EA-84A2-F7792A0B89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469" y="3890596"/>
                <a:ext cx="1203226" cy="804716"/>
              </a:xfrm>
              <a:prstGeom prst="flowChartPunchedTap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DMM </a:t>
                </a:r>
              </a:p>
            </p:txBody>
          </p:sp>
          <p:sp>
            <p:nvSpPr>
              <p:cNvPr id="37" name="Flussdiagramm: Lochstreifen 9">
                <a:extLst>
                  <a:ext uri="{FF2B5EF4-FFF2-40B4-BE49-F238E27FC236}">
                    <a16:creationId xmlns:a16="http://schemas.microsoft.com/office/drawing/2014/main" id="{DFA2E64E-6E64-4619-8898-646645DE16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468" y="1754174"/>
                <a:ext cx="1203226" cy="804716"/>
              </a:xfrm>
              <a:prstGeom prst="flowChartPunchedTap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JC </a:t>
                </a:r>
              </a:p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cipe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8" name="Flussdiagramm: Prozess 11">
                <a:extLst>
                  <a:ext uri="{FF2B5EF4-FFF2-40B4-BE49-F238E27FC236}">
                    <a16:creationId xmlns:a16="http://schemas.microsoft.com/office/drawing/2014/main" id="{A8C5D945-90EA-40CE-B5CF-8B215AD38D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814" y="1768793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1.1</a:t>
                </a:r>
                <a:endParaRPr lang="de-DE" altLang="de-DE" sz="194" dirty="0"/>
              </a:p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ord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agging</a:t>
                </a:r>
                <a:endParaRPr lang="de-DE" altLang="de-DE" sz="194" dirty="0"/>
              </a:p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nd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ranslation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9" name="Flussdiagramm: Dokument 13">
                <a:extLst>
                  <a:ext uri="{FF2B5EF4-FFF2-40B4-BE49-F238E27FC236}">
                    <a16:creationId xmlns:a16="http://schemas.microsoft.com/office/drawing/2014/main" id="{6A3D8A23-FD7A-46B1-8186-99D0D9AA6C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20150" y="1834184"/>
                <a:ext cx="1203227" cy="701626"/>
              </a:xfrm>
              <a:prstGeom prst="flowChartDocument">
                <a:avLst/>
              </a:prstGeom>
              <a:solidFill>
                <a:schemeClr val="bg2"/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ranslated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b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JC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ecipe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0" name="Flussdiagramm: Zentralspeicher 14">
                <a:extLst>
                  <a:ext uri="{FF2B5EF4-FFF2-40B4-BE49-F238E27FC236}">
                    <a16:creationId xmlns:a16="http://schemas.microsoft.com/office/drawing/2014/main" id="{E347DFFB-6EE2-458F-860E-9B20E39815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0339" y="1834184"/>
                <a:ext cx="1203227" cy="644696"/>
              </a:xfrm>
              <a:prstGeom prst="flowChartInternalStorag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orld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ist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1" name="Flussdiagramm: Prozess 15">
                <a:extLst>
                  <a:ext uri="{FF2B5EF4-FFF2-40B4-BE49-F238E27FC236}">
                    <a16:creationId xmlns:a16="http://schemas.microsoft.com/office/drawing/2014/main" id="{C43F91F6-F538-4489-AC0A-13D07AA9BA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814" y="2836619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1.2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emmatising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b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plant and </a:t>
                </a:r>
                <a:b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neral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names</a:t>
                </a:r>
                <a:endParaRPr lang="de-CH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2" name="Flussdiagramm: Zentralspeicher 16">
                <a:extLst>
                  <a:ext uri="{FF2B5EF4-FFF2-40B4-BE49-F238E27FC236}">
                    <a16:creationId xmlns:a16="http://schemas.microsoft.com/office/drawing/2014/main" id="{08E38DC4-0D07-4561-837B-8ABB75C0BD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66468" y="2901478"/>
                <a:ext cx="1203227" cy="644696"/>
              </a:xfrm>
              <a:prstGeom prst="flowChartInternalStorag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ist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JC</a:t>
                </a:r>
                <a:endParaRPr lang="de-DE" altLang="de-DE" sz="194" dirty="0"/>
              </a:p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plant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name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3" name="Flussdiagramm: Zentralspeicher 17">
                <a:extLst>
                  <a:ext uri="{FF2B5EF4-FFF2-40B4-BE49-F238E27FC236}">
                    <a16:creationId xmlns:a16="http://schemas.microsoft.com/office/drawing/2014/main" id="{4221BFEA-9F91-4C23-9F43-A688664862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6832" y="2901479"/>
                <a:ext cx="1203227" cy="644695"/>
              </a:xfrm>
              <a:prstGeom prst="flowChartInternalStorag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ist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JC </a:t>
                </a:r>
                <a:endParaRPr lang="de-DE" altLang="de-DE" sz="194" dirty="0"/>
              </a:p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neral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names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*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4" name="Flussdiagramm: Prozess 18">
                <a:extLst>
                  <a:ext uri="{FF2B5EF4-FFF2-40B4-BE49-F238E27FC236}">
                    <a16:creationId xmlns:a16="http://schemas.microsoft.com/office/drawing/2014/main" id="{E8E038EB-2A18-4A09-852E-C533FB5353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813" y="3904444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1.3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oss-referencing </a:t>
                </a:r>
                <a:b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JC </a:t>
                </a:r>
                <a:r>
                  <a:rPr lang="en-GB" altLang="de-DE" sz="1066" dirty="0">
                    <a:solidFill>
                      <a:srgbClr val="00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–</a:t>
                </a:r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DMM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plant name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5" name="Flussdiagramm: Zentralspeicher 19">
                <a:extLst>
                  <a:ext uri="{FF2B5EF4-FFF2-40B4-BE49-F238E27FC236}">
                    <a16:creationId xmlns:a16="http://schemas.microsoft.com/office/drawing/2014/main" id="{FF62D901-11A1-4AC7-9034-D1AEAF15D0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66468" y="3973598"/>
                <a:ext cx="1203227" cy="644696"/>
              </a:xfrm>
              <a:prstGeom prst="flowChartInternalStorag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34892" rIns="0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Plant names </a:t>
                </a:r>
                <a:endParaRPr lang="en-GB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JC </a:t>
                </a:r>
                <a:r>
                  <a:rPr lang="en-GB" altLang="de-DE" sz="1066" dirty="0">
                    <a:solidFill>
                      <a:srgbClr val="00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–</a:t>
                </a:r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DMM </a:t>
                </a:r>
                <a:b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oss-referenced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7" name="AutoShape 61">
                <a:extLst>
                  <a:ext uri="{FF2B5EF4-FFF2-40B4-BE49-F238E27FC236}">
                    <a16:creationId xmlns:a16="http://schemas.microsoft.com/office/drawing/2014/main" id="{C9BC9FFB-B701-4ADD-B7B3-9D23F87855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813" y="4969961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1.4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apturing</a:t>
                </a:r>
                <a:b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otanical info</a:t>
                </a:r>
                <a:b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from DMM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8" name="AutoShape 65">
                <a:extLst>
                  <a:ext uri="{FF2B5EF4-FFF2-40B4-BE49-F238E27FC236}">
                    <a16:creationId xmlns:a16="http://schemas.microsoft.com/office/drawing/2014/main" id="{F4F8AA58-8C70-405B-AC1A-68EFF8B625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468" y="4953960"/>
                <a:ext cx="1203227" cy="804715"/>
              </a:xfrm>
              <a:prstGeom prst="flowChartPunchedTap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DMM </a:t>
                </a:r>
              </a:p>
            </p:txBody>
          </p:sp>
          <p:sp>
            <p:nvSpPr>
              <p:cNvPr id="50" name="AutoShape 64">
                <a:extLst>
                  <a:ext uri="{FF2B5EF4-FFF2-40B4-BE49-F238E27FC236}">
                    <a16:creationId xmlns:a16="http://schemas.microsoft.com/office/drawing/2014/main" id="{41755DF5-2E35-4CA5-ADC2-15149C3E7B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812" y="6063170"/>
                <a:ext cx="1203227" cy="777020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1.5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apturing  </a:t>
                </a:r>
                <a:b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edicinal plant uses from JC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51" name="AutoShape 63">
                <a:extLst>
                  <a:ext uri="{FF2B5EF4-FFF2-40B4-BE49-F238E27FC236}">
                    <a16:creationId xmlns:a16="http://schemas.microsoft.com/office/drawing/2014/main" id="{0CC52085-DE80-4F3F-B770-D2223CD3FC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4154" y="6126440"/>
                <a:ext cx="1203227" cy="644696"/>
              </a:xfrm>
              <a:prstGeom prst="flowChartInternalStorage">
                <a:avLst/>
              </a:prstGeom>
              <a:solidFill>
                <a:srgbClr val="E1E1FF"/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JC medicinal plant use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53" name="Flussdiagramm: Zentralspeicher 19">
                <a:extLst>
                  <a:ext uri="{FF2B5EF4-FFF2-40B4-BE49-F238E27FC236}">
                    <a16:creationId xmlns:a16="http://schemas.microsoft.com/office/drawing/2014/main" id="{AE5FA77A-217F-42AD-86C0-3DC5F84F69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66468" y="5032510"/>
                <a:ext cx="1203227" cy="644696"/>
              </a:xfrm>
              <a:prstGeom prst="flowChartInternalStorag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ist of plants</a:t>
                </a:r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ich botanical info in DMM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9" name="AutoShape 64">
                <a:extLst>
                  <a:ext uri="{FF2B5EF4-FFF2-40B4-BE49-F238E27FC236}">
                    <a16:creationId xmlns:a16="http://schemas.microsoft.com/office/drawing/2014/main" id="{016217D3-9352-4CA2-A946-533CFF0AE0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812" y="7158697"/>
                <a:ext cx="1203227" cy="777020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1.6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ollating </a:t>
                </a:r>
                <a:b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urnt substances from JC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20" name="Flussdiagramm: Dokument 13">
                <a:extLst>
                  <a:ext uri="{FF2B5EF4-FFF2-40B4-BE49-F238E27FC236}">
                    <a16:creationId xmlns:a16="http://schemas.microsoft.com/office/drawing/2014/main" id="{F16FC93F-60C5-4D07-BFD8-4A9B83D037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9155" y="6138564"/>
                <a:ext cx="1203227" cy="701626"/>
              </a:xfrm>
              <a:prstGeom prst="flowChartDocument">
                <a:avLst/>
              </a:prstGeom>
              <a:solidFill>
                <a:schemeClr val="bg2"/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ranslated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b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JC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ecipe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22" name="AutoShape 63">
                <a:extLst>
                  <a:ext uri="{FF2B5EF4-FFF2-40B4-BE49-F238E27FC236}">
                    <a16:creationId xmlns:a16="http://schemas.microsoft.com/office/drawing/2014/main" id="{7B4614B1-F5D8-408A-ACAC-75E5CFF697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4154" y="7224992"/>
                <a:ext cx="1203227" cy="644696"/>
              </a:xfrm>
              <a:prstGeom prst="flowChartInternalStorag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JC burnt substances*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76" name="Flussdiagramm: Zentralspeicher 19">
                <a:extLst>
                  <a:ext uri="{FF2B5EF4-FFF2-40B4-BE49-F238E27FC236}">
                    <a16:creationId xmlns:a16="http://schemas.microsoft.com/office/drawing/2014/main" id="{430982AA-1D1F-4469-925A-3673E1B94B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0472" y="5034612"/>
                <a:ext cx="1203227" cy="644696"/>
              </a:xfrm>
              <a:prstGeom prst="flowChartInternalStorage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DMM botanical info rich plant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cxnSp>
            <p:nvCxnSpPr>
              <p:cNvPr id="77" name="Gerade Verbindung mit Pfeil 76">
                <a:extLst>
                  <a:ext uri="{FF2B5EF4-FFF2-40B4-BE49-F238E27FC236}">
                    <a16:creationId xmlns:a16="http://schemas.microsoft.com/office/drawing/2014/main" id="{F1237DFE-7BF8-4EE2-AE8B-AA5088FC51FE}"/>
                  </a:ext>
                </a:extLst>
              </p:cNvPr>
              <p:cNvCxnSpPr>
                <a:cxnSpLocks/>
                <a:stCxn id="38" idx="3"/>
                <a:endCxn id="40" idx="1"/>
              </p:cNvCxnSpPr>
              <p:nvPr/>
            </p:nvCxnSpPr>
            <p:spPr>
              <a:xfrm flipV="1">
                <a:off x="3531041" y="2156532"/>
                <a:ext cx="349298" cy="77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Gerade Verbindung mit Pfeil 78">
                <a:extLst>
                  <a:ext uri="{FF2B5EF4-FFF2-40B4-BE49-F238E27FC236}">
                    <a16:creationId xmlns:a16="http://schemas.microsoft.com/office/drawing/2014/main" id="{1A5F341C-C5F2-49C5-9093-08CB185BCCED}"/>
                  </a:ext>
                </a:extLst>
              </p:cNvPr>
              <p:cNvCxnSpPr>
                <a:cxnSpLocks/>
                <a:stCxn id="44" idx="3"/>
                <a:endCxn id="45" idx="1"/>
              </p:cNvCxnSpPr>
              <p:nvPr/>
            </p:nvCxnSpPr>
            <p:spPr>
              <a:xfrm>
                <a:off x="3531040" y="4292955"/>
                <a:ext cx="335428" cy="2991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Gerade Verbindung mit Pfeil 79">
                <a:extLst>
                  <a:ext uri="{FF2B5EF4-FFF2-40B4-BE49-F238E27FC236}">
                    <a16:creationId xmlns:a16="http://schemas.microsoft.com/office/drawing/2014/main" id="{405B55EA-383F-4208-8CE8-15771DD484FF}"/>
                  </a:ext>
                </a:extLst>
              </p:cNvPr>
              <p:cNvCxnSpPr>
                <a:cxnSpLocks/>
                <a:stCxn id="41" idx="3"/>
                <a:endCxn id="42" idx="1"/>
              </p:cNvCxnSpPr>
              <p:nvPr/>
            </p:nvCxnSpPr>
            <p:spPr>
              <a:xfrm flipV="1">
                <a:off x="3531041" y="3223826"/>
                <a:ext cx="335427" cy="130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Gerade Verbindung mit Pfeil 82">
                <a:extLst>
                  <a:ext uri="{FF2B5EF4-FFF2-40B4-BE49-F238E27FC236}">
                    <a16:creationId xmlns:a16="http://schemas.microsoft.com/office/drawing/2014/main" id="{F3A432C2-96A3-4188-A0BB-616D20AD915D}"/>
                  </a:ext>
                </a:extLst>
              </p:cNvPr>
              <p:cNvCxnSpPr>
                <a:cxnSpLocks/>
                <a:stCxn id="47" idx="3"/>
                <a:endCxn id="53" idx="1"/>
              </p:cNvCxnSpPr>
              <p:nvPr/>
            </p:nvCxnSpPr>
            <p:spPr>
              <a:xfrm flipV="1">
                <a:off x="3531040" y="5354858"/>
                <a:ext cx="335428" cy="361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Gerade Verbindung mit Pfeil 84">
                <a:extLst>
                  <a:ext uri="{FF2B5EF4-FFF2-40B4-BE49-F238E27FC236}">
                    <a16:creationId xmlns:a16="http://schemas.microsoft.com/office/drawing/2014/main" id="{B5B2D9E6-9A3B-4BE5-8469-AD851DC960C3}"/>
                  </a:ext>
                </a:extLst>
              </p:cNvPr>
              <p:cNvCxnSpPr>
                <a:cxnSpLocks/>
                <a:stCxn id="50" idx="3"/>
                <a:endCxn id="51" idx="1"/>
              </p:cNvCxnSpPr>
              <p:nvPr/>
            </p:nvCxnSpPr>
            <p:spPr>
              <a:xfrm flipV="1">
                <a:off x="3531039" y="6448788"/>
                <a:ext cx="323115" cy="289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Gerade Verbindung mit Pfeil 88">
                <a:extLst>
                  <a:ext uri="{FF2B5EF4-FFF2-40B4-BE49-F238E27FC236}">
                    <a16:creationId xmlns:a16="http://schemas.microsoft.com/office/drawing/2014/main" id="{9F3504D1-B346-484E-A38F-F82178B34DFD}"/>
                  </a:ext>
                </a:extLst>
              </p:cNvPr>
              <p:cNvCxnSpPr>
                <a:cxnSpLocks/>
                <a:stCxn id="19" idx="3"/>
                <a:endCxn id="22" idx="1"/>
              </p:cNvCxnSpPr>
              <p:nvPr/>
            </p:nvCxnSpPr>
            <p:spPr>
              <a:xfrm>
                <a:off x="3531039" y="7547207"/>
                <a:ext cx="323115" cy="13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Pfeil: nach rechts 112">
                <a:extLst>
                  <a:ext uri="{FF2B5EF4-FFF2-40B4-BE49-F238E27FC236}">
                    <a16:creationId xmlns:a16="http://schemas.microsoft.com/office/drawing/2014/main" id="{6BAD6032-D520-46F5-B7F4-B1ED7E2B3915}"/>
                  </a:ext>
                </a:extLst>
              </p:cNvPr>
              <p:cNvSpPr/>
              <p:nvPr/>
            </p:nvSpPr>
            <p:spPr>
              <a:xfrm>
                <a:off x="2072595" y="6365324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14" name="Pfeil: nach rechts 113">
                <a:extLst>
                  <a:ext uri="{FF2B5EF4-FFF2-40B4-BE49-F238E27FC236}">
                    <a16:creationId xmlns:a16="http://schemas.microsoft.com/office/drawing/2014/main" id="{B8DC9817-4204-4580-8594-824B4A77DB31}"/>
                  </a:ext>
                </a:extLst>
              </p:cNvPr>
              <p:cNvSpPr/>
              <p:nvPr/>
            </p:nvSpPr>
            <p:spPr>
              <a:xfrm>
                <a:off x="2059515" y="4216759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15" name="Pfeil: nach rechts 114">
                <a:extLst>
                  <a:ext uri="{FF2B5EF4-FFF2-40B4-BE49-F238E27FC236}">
                    <a16:creationId xmlns:a16="http://schemas.microsoft.com/office/drawing/2014/main" id="{2609E9F5-FFAA-477C-BEF7-C8FF85E9FD8B}"/>
                  </a:ext>
                </a:extLst>
              </p:cNvPr>
              <p:cNvSpPr/>
              <p:nvPr/>
            </p:nvSpPr>
            <p:spPr>
              <a:xfrm>
                <a:off x="2065669" y="5301652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16" name="Pfeil: nach rechts 115">
                <a:extLst>
                  <a:ext uri="{FF2B5EF4-FFF2-40B4-BE49-F238E27FC236}">
                    <a16:creationId xmlns:a16="http://schemas.microsoft.com/office/drawing/2014/main" id="{E81820A6-6717-45E6-A449-8D035DE08BE4}"/>
                  </a:ext>
                </a:extLst>
              </p:cNvPr>
              <p:cNvSpPr/>
              <p:nvPr/>
            </p:nvSpPr>
            <p:spPr>
              <a:xfrm>
                <a:off x="2058354" y="2079893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cxnSp>
            <p:nvCxnSpPr>
              <p:cNvPr id="118" name="Verbinder: gewinkelt 117">
                <a:extLst>
                  <a:ext uri="{FF2B5EF4-FFF2-40B4-BE49-F238E27FC236}">
                    <a16:creationId xmlns:a16="http://schemas.microsoft.com/office/drawing/2014/main" id="{82952A25-AAEF-4445-A9FA-DC5C8FF45224}"/>
                  </a:ext>
                </a:extLst>
              </p:cNvPr>
              <p:cNvCxnSpPr>
                <a:stCxn id="40" idx="2"/>
                <a:endCxn id="41" idx="0"/>
              </p:cNvCxnSpPr>
              <p:nvPr/>
            </p:nvCxnSpPr>
            <p:spPr>
              <a:xfrm rot="5400000">
                <a:off x="3526822" y="1881487"/>
                <a:ext cx="357739" cy="1552525"/>
              </a:xfrm>
              <a:prstGeom prst="bentConnector3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Verbinder: gewinkelt 168">
                <a:extLst>
                  <a:ext uri="{FF2B5EF4-FFF2-40B4-BE49-F238E27FC236}">
                    <a16:creationId xmlns:a16="http://schemas.microsoft.com/office/drawing/2014/main" id="{2887E82E-4E25-4A8D-AB34-9B0E4E6A2F0C}"/>
                  </a:ext>
                </a:extLst>
              </p:cNvPr>
              <p:cNvCxnSpPr>
                <a:cxnSpLocks/>
                <a:stCxn id="42" idx="2"/>
                <a:endCxn id="44" idx="0"/>
              </p:cNvCxnSpPr>
              <p:nvPr/>
            </p:nvCxnSpPr>
            <p:spPr>
              <a:xfrm rot="5400000">
                <a:off x="3519620" y="2955982"/>
                <a:ext cx="358270" cy="1538655"/>
              </a:xfrm>
              <a:prstGeom prst="bentConnector3">
                <a:avLst>
                  <a:gd name="adj1" fmla="val 50000"/>
                </a:avLst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Verbinder: gewinkelt 171">
                <a:extLst>
                  <a:ext uri="{FF2B5EF4-FFF2-40B4-BE49-F238E27FC236}">
                    <a16:creationId xmlns:a16="http://schemas.microsoft.com/office/drawing/2014/main" id="{617304D1-65DF-4501-B7DA-99F4ED33977A}"/>
                  </a:ext>
                </a:extLst>
              </p:cNvPr>
              <p:cNvCxnSpPr>
                <a:cxnSpLocks/>
                <a:stCxn id="45" idx="2"/>
                <a:endCxn id="47" idx="0"/>
              </p:cNvCxnSpPr>
              <p:nvPr/>
            </p:nvCxnSpPr>
            <p:spPr>
              <a:xfrm rot="5400000">
                <a:off x="3522922" y="4024800"/>
                <a:ext cx="351667" cy="1538655"/>
              </a:xfrm>
              <a:prstGeom prst="bentConnector3">
                <a:avLst>
                  <a:gd name="adj1" fmla="val 50000"/>
                </a:avLst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Verbinder: gewinkelt 180">
                <a:extLst>
                  <a:ext uri="{FF2B5EF4-FFF2-40B4-BE49-F238E27FC236}">
                    <a16:creationId xmlns:a16="http://schemas.microsoft.com/office/drawing/2014/main" id="{BAD802B9-01EC-43C4-9228-03BEFF9A6A6F}"/>
                  </a:ext>
                </a:extLst>
              </p:cNvPr>
              <p:cNvCxnSpPr>
                <a:cxnSpLocks/>
                <a:stCxn id="53" idx="2"/>
                <a:endCxn id="50" idx="0"/>
              </p:cNvCxnSpPr>
              <p:nvPr/>
            </p:nvCxnSpPr>
            <p:spPr>
              <a:xfrm rot="5400000">
                <a:off x="3505772" y="5100860"/>
                <a:ext cx="385964" cy="1538656"/>
              </a:xfrm>
              <a:prstGeom prst="bentConnector3">
                <a:avLst>
                  <a:gd name="adj1" fmla="val 50000"/>
                </a:avLst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4" name="Flussdiagramm: Dokument 13">
                <a:extLst>
                  <a:ext uri="{FF2B5EF4-FFF2-40B4-BE49-F238E27FC236}">
                    <a16:creationId xmlns:a16="http://schemas.microsoft.com/office/drawing/2014/main" id="{6E007CCE-F74D-4F22-BADD-1B37B93EDE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3428" y="7229188"/>
                <a:ext cx="1203227" cy="701626"/>
              </a:xfrm>
              <a:prstGeom prst="flowChartDocument">
                <a:avLst/>
              </a:prstGeom>
              <a:solidFill>
                <a:schemeClr val="bg2"/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ranslated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b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JC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ecipe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85" name="Pfeil: nach rechts 184">
                <a:extLst>
                  <a:ext uri="{FF2B5EF4-FFF2-40B4-BE49-F238E27FC236}">
                    <a16:creationId xmlns:a16="http://schemas.microsoft.com/office/drawing/2014/main" id="{3F907E7E-DC42-415A-9975-BA62459388F9}"/>
                  </a:ext>
                </a:extLst>
              </p:cNvPr>
              <p:cNvSpPr/>
              <p:nvPr/>
            </p:nvSpPr>
            <p:spPr>
              <a:xfrm>
                <a:off x="2086868" y="7455948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95" name="Textfeld 194">
                <a:extLst>
                  <a:ext uri="{FF2B5EF4-FFF2-40B4-BE49-F238E27FC236}">
                    <a16:creationId xmlns:a16="http://schemas.microsoft.com/office/drawing/2014/main" id="{D0FC0F85-FB60-44DE-9655-D8D0B91DCC2F}"/>
                  </a:ext>
                </a:extLst>
              </p:cNvPr>
              <p:cNvSpPr txBox="1"/>
              <p:nvPr/>
            </p:nvSpPr>
            <p:spPr>
              <a:xfrm>
                <a:off x="678879" y="8086313"/>
                <a:ext cx="406906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tage 1 – Gathering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ta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rom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istorical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exts</a:t>
                </a:r>
                <a:endParaRPr lang="de-CH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0" name="Gruppieren 199">
              <a:extLst>
                <a:ext uri="{FF2B5EF4-FFF2-40B4-BE49-F238E27FC236}">
                  <a16:creationId xmlns:a16="http://schemas.microsoft.com/office/drawing/2014/main" id="{D450FBCE-EED7-438E-B5CC-0404C56DC194}"/>
                </a:ext>
              </a:extLst>
            </p:cNvPr>
            <p:cNvGrpSpPr/>
            <p:nvPr/>
          </p:nvGrpSpPr>
          <p:grpSpPr>
            <a:xfrm>
              <a:off x="8270769" y="3683237"/>
              <a:ext cx="4953749" cy="4343872"/>
              <a:chOff x="7750424" y="1762733"/>
              <a:chExt cx="4953749" cy="4343872"/>
            </a:xfrm>
          </p:grpSpPr>
          <p:sp>
            <p:nvSpPr>
              <p:cNvPr id="52" name="Rectangle 73">
                <a:extLst>
                  <a:ext uri="{FF2B5EF4-FFF2-40B4-BE49-F238E27FC236}">
                    <a16:creationId xmlns:a16="http://schemas.microsoft.com/office/drawing/2014/main" id="{521E6EA8-937A-41A4-B53D-75748BB8D6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0424" y="3197028"/>
                <a:ext cx="70529" cy="3389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none" lIns="34892" tIns="34892" rIns="34892" bIns="34892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/>
                <a:endParaRPr lang="de-CH" sz="1745"/>
              </a:p>
            </p:txBody>
          </p:sp>
          <p:sp>
            <p:nvSpPr>
              <p:cNvPr id="24" name="Flussdiagramm: Lochstreifen 9">
                <a:extLst>
                  <a:ext uri="{FF2B5EF4-FFF2-40B4-BE49-F238E27FC236}">
                    <a16:creationId xmlns:a16="http://schemas.microsoft.com/office/drawing/2014/main" id="{15FAD6C1-CDFA-4EA3-8EA5-95D0672E0B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33131" y="2735036"/>
                <a:ext cx="1203226" cy="804716"/>
              </a:xfrm>
              <a:prstGeom prst="flowChartPunchedTap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otanical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iterature</a:t>
                </a:r>
                <a:b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n DMM plant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25" name="Flussdiagramm: Prozess 11">
                <a:extLst>
                  <a:ext uri="{FF2B5EF4-FFF2-40B4-BE49-F238E27FC236}">
                    <a16:creationId xmlns:a16="http://schemas.microsoft.com/office/drawing/2014/main" id="{9DB231A4-0AF4-426A-9403-9359CFD642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59477" y="2749499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2.1</a:t>
                </a:r>
                <a:endParaRPr lang="de-DE" altLang="de-DE" sz="194" dirty="0"/>
              </a:p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ompiling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eported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dentities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plant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26" name="Flussdiagramm: Zentralspeicher 14">
                <a:extLst>
                  <a:ext uri="{FF2B5EF4-FFF2-40B4-BE49-F238E27FC236}">
                    <a16:creationId xmlns:a16="http://schemas.microsoft.com/office/drawing/2014/main" id="{8CAD5C5F-3E66-4614-B634-D5D32EDD05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85818" y="2813978"/>
                <a:ext cx="1203227" cy="644696"/>
              </a:xfrm>
              <a:prstGeom prst="flowChartInternalStorag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ist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otanical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plant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name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27" name="Flussdiagramm: Prozess 15">
                <a:extLst>
                  <a:ext uri="{FF2B5EF4-FFF2-40B4-BE49-F238E27FC236}">
                    <a16:creationId xmlns:a16="http://schemas.microsoft.com/office/drawing/2014/main" id="{C98289CF-47B5-4B05-A135-6C32AB452C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59477" y="3817325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2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oss-</a:t>
                </a: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hecking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otanical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names</a:t>
                </a:r>
                <a:b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ith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MPNS</a:t>
                </a:r>
                <a:endParaRPr lang="de-CH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28" name="Flussdiagramm: Zentralspeicher 16">
                <a:extLst>
                  <a:ext uri="{FF2B5EF4-FFF2-40B4-BE49-F238E27FC236}">
                    <a16:creationId xmlns:a16="http://schemas.microsoft.com/office/drawing/2014/main" id="{ECE9B88C-D55A-4234-BA9E-F6EA9277BB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85819" y="3883288"/>
                <a:ext cx="1203227" cy="644696"/>
              </a:xfrm>
              <a:prstGeom prst="flowChartInternalStorag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PNS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validated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plant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name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29" name="Flussdiagramm: Prozess 18">
                <a:extLst>
                  <a:ext uri="{FF2B5EF4-FFF2-40B4-BE49-F238E27FC236}">
                    <a16:creationId xmlns:a16="http://schemas.microsoft.com/office/drawing/2014/main" id="{7571808A-989A-4D4C-A330-C514CAFFC2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59476" y="4885150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2.3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Establishing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ist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suggested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andidate</a:t>
                </a:r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plant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0" name="Flussdiagramm: Zentralspeicher 19">
                <a:extLst>
                  <a:ext uri="{FF2B5EF4-FFF2-40B4-BE49-F238E27FC236}">
                    <a16:creationId xmlns:a16="http://schemas.microsoft.com/office/drawing/2014/main" id="{C49FB073-5EE4-4754-9A86-1B0C0497E7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85817" y="4951824"/>
                <a:ext cx="1203227" cy="644696"/>
              </a:xfrm>
              <a:prstGeom prst="flowChartInternalStorage">
                <a:avLst/>
              </a:prstGeom>
              <a:solidFill>
                <a:srgbClr val="E7CFB7"/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Suggested candidate plants (CPs)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2" name="Flussdiagramm: Zentralspeicher 19">
                <a:extLst>
                  <a:ext uri="{FF2B5EF4-FFF2-40B4-BE49-F238E27FC236}">
                    <a16:creationId xmlns:a16="http://schemas.microsoft.com/office/drawing/2014/main" id="{39A7C81A-F90F-4F36-A607-83D2E51017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33130" y="1762733"/>
                <a:ext cx="1203227" cy="644696"/>
              </a:xfrm>
              <a:prstGeom prst="flowChartInternalStorag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ist of plants</a:t>
                </a:r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ich botanical info in DMM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3" name="Flussdiagramm: Lochstreifen 8">
                <a:extLst>
                  <a:ext uri="{FF2B5EF4-FFF2-40B4-BE49-F238E27FC236}">
                    <a16:creationId xmlns:a16="http://schemas.microsoft.com/office/drawing/2014/main" id="{2A3409D0-4A9A-41C3-9D39-453EDF8006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33132" y="3814401"/>
                <a:ext cx="1203226" cy="804716"/>
              </a:xfrm>
              <a:prstGeom prst="flowChartPunchedTap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Kew‘s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MPN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19" name="Pfeil: nach rechts 118">
                <a:extLst>
                  <a:ext uri="{FF2B5EF4-FFF2-40B4-BE49-F238E27FC236}">
                    <a16:creationId xmlns:a16="http://schemas.microsoft.com/office/drawing/2014/main" id="{DF0D7BD9-A5E1-4DA5-B924-6D53DB028BF7}"/>
                  </a:ext>
                </a:extLst>
              </p:cNvPr>
              <p:cNvSpPr/>
              <p:nvPr/>
            </p:nvSpPr>
            <p:spPr>
              <a:xfrm>
                <a:off x="9397330" y="3073914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22" name="Pfeil: nach rechts 121">
                <a:extLst>
                  <a:ext uri="{FF2B5EF4-FFF2-40B4-BE49-F238E27FC236}">
                    <a16:creationId xmlns:a16="http://schemas.microsoft.com/office/drawing/2014/main" id="{60370204-F3C0-4352-ADB2-D62685689108}"/>
                  </a:ext>
                </a:extLst>
              </p:cNvPr>
              <p:cNvSpPr/>
              <p:nvPr/>
            </p:nvSpPr>
            <p:spPr>
              <a:xfrm>
                <a:off x="9400978" y="4148486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23" name="Pfeil: nach rechts 122">
                <a:extLst>
                  <a:ext uri="{FF2B5EF4-FFF2-40B4-BE49-F238E27FC236}">
                    <a16:creationId xmlns:a16="http://schemas.microsoft.com/office/drawing/2014/main" id="{922980E2-3CA6-4880-BB66-AD8E804BA7C6}"/>
                  </a:ext>
                </a:extLst>
              </p:cNvPr>
              <p:cNvSpPr/>
              <p:nvPr/>
            </p:nvSpPr>
            <p:spPr>
              <a:xfrm rot="5400000">
                <a:off x="8644048" y="2495908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cxnSp>
            <p:nvCxnSpPr>
              <p:cNvPr id="125" name="Gerade Verbindung mit Pfeil 124">
                <a:extLst>
                  <a:ext uri="{FF2B5EF4-FFF2-40B4-BE49-F238E27FC236}">
                    <a16:creationId xmlns:a16="http://schemas.microsoft.com/office/drawing/2014/main" id="{E2F6F2D6-ED89-4BEA-BC06-E41EB8AAE344}"/>
                  </a:ext>
                </a:extLst>
              </p:cNvPr>
              <p:cNvCxnSpPr>
                <a:cxnSpLocks/>
                <a:stCxn id="25" idx="3"/>
                <a:endCxn id="26" idx="1"/>
              </p:cNvCxnSpPr>
              <p:nvPr/>
            </p:nvCxnSpPr>
            <p:spPr>
              <a:xfrm flipV="1">
                <a:off x="10862704" y="3136326"/>
                <a:ext cx="323114" cy="168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Gerade Verbindung mit Pfeil 127">
                <a:extLst>
                  <a:ext uri="{FF2B5EF4-FFF2-40B4-BE49-F238E27FC236}">
                    <a16:creationId xmlns:a16="http://schemas.microsoft.com/office/drawing/2014/main" id="{88F34B82-B085-45F5-9719-ABE0B5066F9C}"/>
                  </a:ext>
                </a:extLst>
              </p:cNvPr>
              <p:cNvCxnSpPr>
                <a:cxnSpLocks/>
                <a:stCxn id="27" idx="3"/>
                <a:endCxn id="28" idx="1"/>
              </p:cNvCxnSpPr>
              <p:nvPr/>
            </p:nvCxnSpPr>
            <p:spPr>
              <a:xfrm flipV="1">
                <a:off x="10862704" y="4205636"/>
                <a:ext cx="323115" cy="2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Gerade Verbindung mit Pfeil 128">
                <a:extLst>
                  <a:ext uri="{FF2B5EF4-FFF2-40B4-BE49-F238E27FC236}">
                    <a16:creationId xmlns:a16="http://schemas.microsoft.com/office/drawing/2014/main" id="{53BB6547-FCFD-4803-AC99-A49F69EA7E14}"/>
                  </a:ext>
                </a:extLst>
              </p:cNvPr>
              <p:cNvCxnSpPr>
                <a:cxnSpLocks/>
                <a:stCxn id="29" idx="3"/>
                <a:endCxn id="30" idx="1"/>
              </p:cNvCxnSpPr>
              <p:nvPr/>
            </p:nvCxnSpPr>
            <p:spPr>
              <a:xfrm>
                <a:off x="10862703" y="5273661"/>
                <a:ext cx="323114" cy="511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Verbinder: gewinkelt 174">
                <a:extLst>
                  <a:ext uri="{FF2B5EF4-FFF2-40B4-BE49-F238E27FC236}">
                    <a16:creationId xmlns:a16="http://schemas.microsoft.com/office/drawing/2014/main" id="{71D862FA-5791-404F-AEE0-B251F321E606}"/>
                  </a:ext>
                </a:extLst>
              </p:cNvPr>
              <p:cNvCxnSpPr>
                <a:cxnSpLocks/>
                <a:stCxn id="26" idx="2"/>
                <a:endCxn id="27" idx="0"/>
              </p:cNvCxnSpPr>
              <p:nvPr/>
            </p:nvCxnSpPr>
            <p:spPr>
              <a:xfrm rot="5400000">
                <a:off x="10844937" y="2874829"/>
                <a:ext cx="358651" cy="1526341"/>
              </a:xfrm>
              <a:prstGeom prst="bentConnector3">
                <a:avLst>
                  <a:gd name="adj1" fmla="val 50000"/>
                </a:avLst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Verbinder: gewinkelt 177">
                <a:extLst>
                  <a:ext uri="{FF2B5EF4-FFF2-40B4-BE49-F238E27FC236}">
                    <a16:creationId xmlns:a16="http://schemas.microsoft.com/office/drawing/2014/main" id="{A596F9A8-F5B0-4C28-B977-D040C98CF9C4}"/>
                  </a:ext>
                </a:extLst>
              </p:cNvPr>
              <p:cNvCxnSpPr>
                <a:cxnSpLocks/>
                <a:stCxn id="28" idx="2"/>
                <a:endCxn id="29" idx="0"/>
              </p:cNvCxnSpPr>
              <p:nvPr/>
            </p:nvCxnSpPr>
            <p:spPr>
              <a:xfrm rot="5400000">
                <a:off x="10845679" y="3943396"/>
                <a:ext cx="357166" cy="1526343"/>
              </a:xfrm>
              <a:prstGeom prst="bentConnector3">
                <a:avLst>
                  <a:gd name="adj1" fmla="val 50000"/>
                </a:avLst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6" name="Textfeld 195">
                <a:extLst>
                  <a:ext uri="{FF2B5EF4-FFF2-40B4-BE49-F238E27FC236}">
                    <a16:creationId xmlns:a16="http://schemas.microsoft.com/office/drawing/2014/main" id="{4ABD15B8-4C88-4662-B001-C932D4A7B942}"/>
                  </a:ext>
                </a:extLst>
              </p:cNvPr>
              <p:cNvSpPr txBox="1"/>
              <p:nvPr/>
            </p:nvSpPr>
            <p:spPr>
              <a:xfrm>
                <a:off x="7750424" y="5798828"/>
                <a:ext cx="495374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tage 2 –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stablishing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e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ist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f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uggested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ndidate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plants</a:t>
                </a:r>
              </a:p>
            </p:txBody>
          </p:sp>
        </p:grpSp>
        <p:grpSp>
          <p:nvGrpSpPr>
            <p:cNvPr id="202" name="Gruppieren 201">
              <a:extLst>
                <a:ext uri="{FF2B5EF4-FFF2-40B4-BE49-F238E27FC236}">
                  <a16:creationId xmlns:a16="http://schemas.microsoft.com/office/drawing/2014/main" id="{8D00565D-A3E0-4911-BC4C-D01C1B7C1ECC}"/>
                </a:ext>
              </a:extLst>
            </p:cNvPr>
            <p:cNvGrpSpPr/>
            <p:nvPr/>
          </p:nvGrpSpPr>
          <p:grpSpPr>
            <a:xfrm>
              <a:off x="2113624" y="10558201"/>
              <a:ext cx="4364671" cy="4414555"/>
              <a:chOff x="692707" y="9379278"/>
              <a:chExt cx="4364671" cy="4414555"/>
            </a:xfrm>
          </p:grpSpPr>
          <p:sp>
            <p:nvSpPr>
              <p:cNvPr id="35" name="AutoShape 61">
                <a:extLst>
                  <a:ext uri="{FF2B5EF4-FFF2-40B4-BE49-F238E27FC236}">
                    <a16:creationId xmlns:a16="http://schemas.microsoft.com/office/drawing/2014/main" id="{F5118377-1A6E-41E8-80B3-AE1D717E96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812" y="10344470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3.1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ollating</a:t>
                </a:r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otanical info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9" name="AutoShape 65">
                <a:extLst>
                  <a:ext uri="{FF2B5EF4-FFF2-40B4-BE49-F238E27FC236}">
                    <a16:creationId xmlns:a16="http://schemas.microsoft.com/office/drawing/2014/main" id="{6BE13635-9AE6-4521-A854-796AA895B7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467" y="10328469"/>
                <a:ext cx="1203227" cy="804715"/>
              </a:xfrm>
              <a:prstGeom prst="flowChartPunchedTap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Floristic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orks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FW)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54" name="AutoShape 64">
                <a:extLst>
                  <a:ext uri="{FF2B5EF4-FFF2-40B4-BE49-F238E27FC236}">
                    <a16:creationId xmlns:a16="http://schemas.microsoft.com/office/drawing/2014/main" id="{4C9D643B-3C5A-4FF3-8410-872F465906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811" y="11437679"/>
                <a:ext cx="1203227" cy="777020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3.2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ollating medicinal uses </a:t>
                </a:r>
              </a:p>
            </p:txBody>
          </p:sp>
          <p:sp>
            <p:nvSpPr>
              <p:cNvPr id="55" name="AutoShape 63">
                <a:extLst>
                  <a:ext uri="{FF2B5EF4-FFF2-40B4-BE49-F238E27FC236}">
                    <a16:creationId xmlns:a16="http://schemas.microsoft.com/office/drawing/2014/main" id="{1F61E626-75A3-4BD1-8201-7C4C30D118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4150" y="11501686"/>
                <a:ext cx="1203227" cy="644696"/>
              </a:xfrm>
              <a:prstGeom prst="flowChartInternalStorag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edicinal uses CPs (1)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56" name="Flussdiagramm: Zentralspeicher 19">
                <a:extLst>
                  <a:ext uri="{FF2B5EF4-FFF2-40B4-BE49-F238E27FC236}">
                    <a16:creationId xmlns:a16="http://schemas.microsoft.com/office/drawing/2014/main" id="{07DA8A01-3AB6-4CEA-84B4-DA2ADDC694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4151" y="10409215"/>
                <a:ext cx="1203227" cy="644696"/>
              </a:xfrm>
              <a:prstGeom prst="flowChartInternalStorage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FW botanical info CP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57" name="AutoShape 64">
                <a:extLst>
                  <a:ext uri="{FF2B5EF4-FFF2-40B4-BE49-F238E27FC236}">
                    <a16:creationId xmlns:a16="http://schemas.microsoft.com/office/drawing/2014/main" id="{16852892-5DBB-4C1C-8E3C-C0F2619FE7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811" y="12533206"/>
                <a:ext cx="1203227" cy="777020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.3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ollating medicinal uses </a:t>
                </a:r>
              </a:p>
            </p:txBody>
          </p:sp>
          <p:sp>
            <p:nvSpPr>
              <p:cNvPr id="58" name="Flussdiagramm: Zentralspeicher 19">
                <a:extLst>
                  <a:ext uri="{FF2B5EF4-FFF2-40B4-BE49-F238E27FC236}">
                    <a16:creationId xmlns:a16="http://schemas.microsoft.com/office/drawing/2014/main" id="{58D647E3-4121-40A7-B348-806F6D33CB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465" y="9379278"/>
                <a:ext cx="1203227" cy="644696"/>
              </a:xfrm>
              <a:prstGeom prst="flowChartInternalStorage">
                <a:avLst/>
              </a:prstGeom>
              <a:solidFill>
                <a:srgbClr val="E7CFB7"/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Suggested candidate plants (CPs)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59" name="AutoShape 65">
                <a:extLst>
                  <a:ext uri="{FF2B5EF4-FFF2-40B4-BE49-F238E27FC236}">
                    <a16:creationId xmlns:a16="http://schemas.microsoft.com/office/drawing/2014/main" id="{91575090-154A-4E4E-B96A-F133552DC4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465" y="11437679"/>
                <a:ext cx="1203227" cy="804715"/>
              </a:xfrm>
              <a:prstGeom prst="flowChartPunchedTap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Herbal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edicine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,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Ethnobotany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60" name="AutoShape 65">
                <a:extLst>
                  <a:ext uri="{FF2B5EF4-FFF2-40B4-BE49-F238E27FC236}">
                    <a16:creationId xmlns:a16="http://schemas.microsoft.com/office/drawing/2014/main" id="{13F2ED1E-A84F-4960-8782-B38E014065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465" y="12530888"/>
                <a:ext cx="1203227" cy="804715"/>
              </a:xfrm>
              <a:prstGeom prst="flowChartPunchedTap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Human </a:t>
                </a:r>
                <a:b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</a:b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linical</a:t>
                </a:r>
                <a:r>
                  <a:rPr lang="de-DE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altLang="de-DE" sz="1066" dirty="0" err="1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rials</a:t>
                </a:r>
                <a:endParaRPr lang="de-DE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61" name="AutoShape 63">
                <a:extLst>
                  <a:ext uri="{FF2B5EF4-FFF2-40B4-BE49-F238E27FC236}">
                    <a16:creationId xmlns:a16="http://schemas.microsoft.com/office/drawing/2014/main" id="{5A92177A-5F34-43BD-B506-6E113BEC96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4150" y="12592609"/>
                <a:ext cx="1203227" cy="644696"/>
              </a:xfrm>
              <a:prstGeom prst="flowChartInternalStorag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edicinal uses CPs (2)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cxnSp>
            <p:nvCxnSpPr>
              <p:cNvPr id="97" name="Gerade Verbindung mit Pfeil 96">
                <a:extLst>
                  <a:ext uri="{FF2B5EF4-FFF2-40B4-BE49-F238E27FC236}">
                    <a16:creationId xmlns:a16="http://schemas.microsoft.com/office/drawing/2014/main" id="{162858EC-306E-4EE6-BDDE-39856548E936}"/>
                  </a:ext>
                </a:extLst>
              </p:cNvPr>
              <p:cNvCxnSpPr>
                <a:cxnSpLocks/>
                <a:stCxn id="35" idx="3"/>
                <a:endCxn id="56" idx="1"/>
              </p:cNvCxnSpPr>
              <p:nvPr/>
            </p:nvCxnSpPr>
            <p:spPr>
              <a:xfrm flipV="1">
                <a:off x="3531039" y="10731563"/>
                <a:ext cx="323112" cy="1418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Gerade Verbindung mit Pfeil 97">
                <a:extLst>
                  <a:ext uri="{FF2B5EF4-FFF2-40B4-BE49-F238E27FC236}">
                    <a16:creationId xmlns:a16="http://schemas.microsoft.com/office/drawing/2014/main" id="{7A2F2C28-7A47-45BE-A8A2-5C28C25BFFEC}"/>
                  </a:ext>
                </a:extLst>
              </p:cNvPr>
              <p:cNvCxnSpPr>
                <a:cxnSpLocks/>
                <a:stCxn id="57" idx="3"/>
                <a:endCxn id="61" idx="1"/>
              </p:cNvCxnSpPr>
              <p:nvPr/>
            </p:nvCxnSpPr>
            <p:spPr>
              <a:xfrm flipV="1">
                <a:off x="3531038" y="12914957"/>
                <a:ext cx="323112" cy="6759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Gerade Verbindung mit Pfeil 98">
                <a:extLst>
                  <a:ext uri="{FF2B5EF4-FFF2-40B4-BE49-F238E27FC236}">
                    <a16:creationId xmlns:a16="http://schemas.microsoft.com/office/drawing/2014/main" id="{82E1D4AA-5515-412E-9B03-F1F71888A3F5}"/>
                  </a:ext>
                </a:extLst>
              </p:cNvPr>
              <p:cNvCxnSpPr>
                <a:cxnSpLocks/>
                <a:stCxn id="54" idx="3"/>
                <a:endCxn id="55" idx="1"/>
              </p:cNvCxnSpPr>
              <p:nvPr/>
            </p:nvCxnSpPr>
            <p:spPr>
              <a:xfrm flipV="1">
                <a:off x="3531038" y="11824034"/>
                <a:ext cx="323112" cy="2155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Pfeil: nach rechts 107">
                <a:extLst>
                  <a:ext uri="{FF2B5EF4-FFF2-40B4-BE49-F238E27FC236}">
                    <a16:creationId xmlns:a16="http://schemas.microsoft.com/office/drawing/2014/main" id="{3C0EFA11-B225-4825-ACE8-04F6CE58D1BC}"/>
                  </a:ext>
                </a:extLst>
              </p:cNvPr>
              <p:cNvSpPr/>
              <p:nvPr/>
            </p:nvSpPr>
            <p:spPr>
              <a:xfrm>
                <a:off x="2065669" y="12843454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09" name="Pfeil: nach rechts 108">
                <a:extLst>
                  <a:ext uri="{FF2B5EF4-FFF2-40B4-BE49-F238E27FC236}">
                    <a16:creationId xmlns:a16="http://schemas.microsoft.com/office/drawing/2014/main" id="{E4735E05-A4A8-4C93-ABA3-510D6A24DB38}"/>
                  </a:ext>
                </a:extLst>
              </p:cNvPr>
              <p:cNvSpPr/>
              <p:nvPr/>
            </p:nvSpPr>
            <p:spPr>
              <a:xfrm>
                <a:off x="2072595" y="11750245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10" name="Pfeil: nach rechts 109">
                <a:extLst>
                  <a:ext uri="{FF2B5EF4-FFF2-40B4-BE49-F238E27FC236}">
                    <a16:creationId xmlns:a16="http://schemas.microsoft.com/office/drawing/2014/main" id="{69AE6276-2C9E-4A92-91B2-451B67ECD05C}"/>
                  </a:ext>
                </a:extLst>
              </p:cNvPr>
              <p:cNvSpPr/>
              <p:nvPr/>
            </p:nvSpPr>
            <p:spPr>
              <a:xfrm>
                <a:off x="2072595" y="10660277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11" name="Pfeil: nach rechts 110">
                <a:extLst>
                  <a:ext uri="{FF2B5EF4-FFF2-40B4-BE49-F238E27FC236}">
                    <a16:creationId xmlns:a16="http://schemas.microsoft.com/office/drawing/2014/main" id="{8EA0ED66-2654-4A75-8BD1-C9D6F2BAE268}"/>
                  </a:ext>
                </a:extLst>
              </p:cNvPr>
              <p:cNvSpPr/>
              <p:nvPr/>
            </p:nvSpPr>
            <p:spPr>
              <a:xfrm rot="5400000">
                <a:off x="1302493" y="10113448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97" name="Textfeld 196">
                <a:extLst>
                  <a:ext uri="{FF2B5EF4-FFF2-40B4-BE49-F238E27FC236}">
                    <a16:creationId xmlns:a16="http://schemas.microsoft.com/office/drawing/2014/main" id="{747CE14E-3AE3-4E77-BDEF-16581EF801D3}"/>
                  </a:ext>
                </a:extLst>
              </p:cNvPr>
              <p:cNvSpPr txBox="1"/>
              <p:nvPr/>
            </p:nvSpPr>
            <p:spPr>
              <a:xfrm>
                <a:off x="692707" y="13486056"/>
                <a:ext cx="413134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tage 3 – Gathering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ta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rom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modern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ources</a:t>
                </a:r>
                <a:endParaRPr lang="de-CH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1" name="Gruppieren 200">
              <a:extLst>
                <a:ext uri="{FF2B5EF4-FFF2-40B4-BE49-F238E27FC236}">
                  <a16:creationId xmlns:a16="http://schemas.microsoft.com/office/drawing/2014/main" id="{7B6BE1D1-5484-4B85-B974-B31A46656585}"/>
                </a:ext>
              </a:extLst>
            </p:cNvPr>
            <p:cNvGrpSpPr/>
            <p:nvPr/>
          </p:nvGrpSpPr>
          <p:grpSpPr>
            <a:xfrm>
              <a:off x="8236825" y="8806544"/>
              <a:ext cx="5175820" cy="6180873"/>
              <a:chOff x="7719082" y="7526087"/>
              <a:chExt cx="5175820" cy="6180873"/>
            </a:xfrm>
          </p:grpSpPr>
          <p:sp>
            <p:nvSpPr>
              <p:cNvPr id="63" name="AutoShape 61">
                <a:extLst>
                  <a:ext uri="{FF2B5EF4-FFF2-40B4-BE49-F238E27FC236}">
                    <a16:creationId xmlns:a16="http://schemas.microsoft.com/office/drawing/2014/main" id="{2783AD02-FCAF-4EF6-8199-E1EBC0ED4B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69365" y="7859739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4.1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otanical comparative analysis</a:t>
                </a:r>
              </a:p>
            </p:txBody>
          </p:sp>
          <p:sp>
            <p:nvSpPr>
              <p:cNvPr id="64" name="AutoShape 64">
                <a:extLst>
                  <a:ext uri="{FF2B5EF4-FFF2-40B4-BE49-F238E27FC236}">
                    <a16:creationId xmlns:a16="http://schemas.microsoft.com/office/drawing/2014/main" id="{01230135-C019-4DAC-BE0A-E8FD88AE10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72388" y="8904597"/>
                <a:ext cx="1203227" cy="777020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.1+5.3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Data processing and statistical evaluation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65" name="Rectangle 73">
                <a:extLst>
                  <a:ext uri="{FF2B5EF4-FFF2-40B4-BE49-F238E27FC236}">
                    <a16:creationId xmlns:a16="http://schemas.microsoft.com/office/drawing/2014/main" id="{E28F8844-2AFA-4014-834F-D21DBF8908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59477" y="8666417"/>
                <a:ext cx="70529" cy="3389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none" lIns="34892" tIns="34892" rIns="34892" bIns="34892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/>
                <a:endParaRPr lang="de-CH" sz="1745"/>
              </a:p>
            </p:txBody>
          </p:sp>
          <p:sp>
            <p:nvSpPr>
              <p:cNvPr id="66" name="Flussdiagramm: Zentralspeicher 19">
                <a:extLst>
                  <a:ext uri="{FF2B5EF4-FFF2-40B4-BE49-F238E27FC236}">
                    <a16:creationId xmlns:a16="http://schemas.microsoft.com/office/drawing/2014/main" id="{6A5D7683-6440-4826-BFE5-E8C055EA29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80429" y="8970759"/>
                <a:ext cx="1203227" cy="644696"/>
              </a:xfrm>
              <a:prstGeom prst="flowChartInternalStorag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esults botanical analysi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67" name="Flussdiagramm: Zentralspeicher 19">
                <a:extLst>
                  <a:ext uri="{FF2B5EF4-FFF2-40B4-BE49-F238E27FC236}">
                    <a16:creationId xmlns:a16="http://schemas.microsoft.com/office/drawing/2014/main" id="{0E566BE6-AF5D-46CD-92E4-EEC547B39D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43019" y="7526087"/>
                <a:ext cx="1203227" cy="644696"/>
              </a:xfrm>
              <a:prstGeom prst="flowChartInternalStorage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DMM botanical info rich plant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68" name="AutoShape 63">
                <a:extLst>
                  <a:ext uri="{FF2B5EF4-FFF2-40B4-BE49-F238E27FC236}">
                    <a16:creationId xmlns:a16="http://schemas.microsoft.com/office/drawing/2014/main" id="{3AC5CB69-AA9D-4885-9C31-9E63431AB5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85817" y="9925463"/>
                <a:ext cx="1203227" cy="644696"/>
              </a:xfrm>
              <a:prstGeom prst="flowChartInternalStorage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b="1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Final summary candidate plants</a:t>
                </a:r>
                <a:endParaRPr lang="en-GB" altLang="de-DE" sz="1745" b="1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69" name="Flussdiagramm: Zentralspeicher 19">
                <a:extLst>
                  <a:ext uri="{FF2B5EF4-FFF2-40B4-BE49-F238E27FC236}">
                    <a16:creationId xmlns:a16="http://schemas.microsoft.com/office/drawing/2014/main" id="{32EF4A11-75A5-4652-A1EE-0E5AFA52EC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43019" y="8360663"/>
                <a:ext cx="1203227" cy="644696"/>
              </a:xfrm>
              <a:prstGeom prst="flowChartInternalStorage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FW botanical info CP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71" name="AutoShape 61">
                <a:extLst>
                  <a:ext uri="{FF2B5EF4-FFF2-40B4-BE49-F238E27FC236}">
                    <a16:creationId xmlns:a16="http://schemas.microsoft.com/office/drawing/2014/main" id="{48ACAF13-EBBD-4746-B7F1-2CD285D7AB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43536" y="11840035"/>
                <a:ext cx="1203227" cy="777021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4.2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edicinal comparative analysis</a:t>
                </a:r>
              </a:p>
            </p:txBody>
          </p:sp>
          <p:sp>
            <p:nvSpPr>
              <p:cNvPr id="72" name="AutoShape 64">
                <a:extLst>
                  <a:ext uri="{FF2B5EF4-FFF2-40B4-BE49-F238E27FC236}">
                    <a16:creationId xmlns:a16="http://schemas.microsoft.com/office/drawing/2014/main" id="{99EC9A6B-1646-4456-93AF-4DC40362D5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43536" y="10800518"/>
                <a:ext cx="1203227" cy="777020"/>
              </a:xfrm>
              <a:prstGeom prst="flowChartProcess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de-CH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.2+5.3</a:t>
                </a:r>
                <a:endParaRPr lang="de-CH" altLang="de-DE" sz="194" dirty="0"/>
              </a:p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Data processing and statistical evaluation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73" name="Flussdiagramm: Zentralspeicher 19">
                <a:extLst>
                  <a:ext uri="{FF2B5EF4-FFF2-40B4-BE49-F238E27FC236}">
                    <a16:creationId xmlns:a16="http://schemas.microsoft.com/office/drawing/2014/main" id="{3C495161-2733-4D02-99E7-4C5D61BB42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85817" y="10866680"/>
                <a:ext cx="1203227" cy="644696"/>
              </a:xfrm>
              <a:prstGeom prst="flowChartInternalStorage">
                <a:avLst/>
              </a:prstGeom>
              <a:noFill/>
              <a:ln w="12700">
                <a:solidFill>
                  <a:srgbClr val="1F3763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esults medicinal analysi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74" name="Flussdiagramm: Zentralspeicher 19">
                <a:extLst>
                  <a:ext uri="{FF2B5EF4-FFF2-40B4-BE49-F238E27FC236}">
                    <a16:creationId xmlns:a16="http://schemas.microsoft.com/office/drawing/2014/main" id="{07ED87BD-D0C1-4BDB-8B6B-D00FA30632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41435" y="11499680"/>
                <a:ext cx="1203227" cy="644696"/>
              </a:xfrm>
              <a:prstGeom prst="flowChartInternalStorage">
                <a:avLst/>
              </a:prstGeom>
              <a:solidFill>
                <a:srgbClr val="E1E1FF"/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JC medicinal plant uses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75" name="Flussdiagramm: Zentralspeicher 19">
                <a:extLst>
                  <a:ext uri="{FF2B5EF4-FFF2-40B4-BE49-F238E27FC236}">
                    <a16:creationId xmlns:a16="http://schemas.microsoft.com/office/drawing/2014/main" id="{5922BF86-6A32-4C57-90E8-DB9A9433AA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41435" y="12348200"/>
                <a:ext cx="1203227" cy="644696"/>
              </a:xfrm>
              <a:prstGeom prst="flowChartInternalStorag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2700">
                <a:solidFill>
                  <a:srgbClr val="1F3763"/>
                </a:solidFill>
                <a:miter lim="800000"/>
                <a:headEnd/>
                <a:tailEnd/>
              </a:ln>
            </p:spPr>
            <p:txBody>
              <a:bodyPr vert="horz" wrap="square" lIns="34892" tIns="34892" rIns="34892" bIns="34892" numCol="1" anchor="ctr" anchorCtr="0" compatLnSpc="1">
                <a:prstTxWarp prst="textNoShape">
                  <a:avLst/>
                </a:prstTxWarp>
              </a:bodyPr>
              <a:lstStyle/>
              <a:p>
                <a:pPr algn="ctr" defTabSz="886236" eaLnBrk="0" fontAlgn="base" hangingPunct="0"/>
                <a:r>
                  <a:rPr lang="en-GB" altLang="de-DE" sz="1066" dirty="0">
                    <a:solidFill>
                      <a:srgbClr val="00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edicinal uses CPs (1 &amp; 2)</a:t>
                </a:r>
                <a:endParaRPr lang="en-GB" altLang="de-DE" sz="1745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20" name="Pfeil: nach rechts 119">
                <a:extLst>
                  <a:ext uri="{FF2B5EF4-FFF2-40B4-BE49-F238E27FC236}">
                    <a16:creationId xmlns:a16="http://schemas.microsoft.com/office/drawing/2014/main" id="{09DFBD80-1A01-4F23-89A1-F41DB3D1FCA2}"/>
                  </a:ext>
                </a:extLst>
              </p:cNvPr>
              <p:cNvSpPr/>
              <p:nvPr/>
            </p:nvSpPr>
            <p:spPr>
              <a:xfrm>
                <a:off x="9397330" y="8181082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sp>
            <p:nvSpPr>
              <p:cNvPr id="124" name="Pfeil: nach rechts 123">
                <a:extLst>
                  <a:ext uri="{FF2B5EF4-FFF2-40B4-BE49-F238E27FC236}">
                    <a16:creationId xmlns:a16="http://schemas.microsoft.com/office/drawing/2014/main" id="{AAC87848-8E3B-43C5-9CB1-AB36ADA730D3}"/>
                  </a:ext>
                </a:extLst>
              </p:cNvPr>
              <p:cNvSpPr/>
              <p:nvPr/>
            </p:nvSpPr>
            <p:spPr>
              <a:xfrm>
                <a:off x="9374465" y="12142878"/>
                <a:ext cx="201168" cy="179581"/>
              </a:xfrm>
              <a:prstGeom prst="righ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  <p:cxnSp>
            <p:nvCxnSpPr>
              <p:cNvPr id="130" name="Gerade Verbindung mit Pfeil 129">
                <a:extLst>
                  <a:ext uri="{FF2B5EF4-FFF2-40B4-BE49-F238E27FC236}">
                    <a16:creationId xmlns:a16="http://schemas.microsoft.com/office/drawing/2014/main" id="{86D04CB1-02D8-47B8-91B6-4C36F58DD9DA}"/>
                  </a:ext>
                </a:extLst>
              </p:cNvPr>
              <p:cNvCxnSpPr>
                <a:cxnSpLocks/>
                <a:stCxn id="64" idx="3"/>
                <a:endCxn id="66" idx="1"/>
              </p:cNvCxnSpPr>
              <p:nvPr/>
            </p:nvCxnSpPr>
            <p:spPr>
              <a:xfrm>
                <a:off x="10875615" y="9293107"/>
                <a:ext cx="304814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Gerade Verbindung mit Pfeil 136">
                <a:extLst>
                  <a:ext uri="{FF2B5EF4-FFF2-40B4-BE49-F238E27FC236}">
                    <a16:creationId xmlns:a16="http://schemas.microsoft.com/office/drawing/2014/main" id="{A27C7E30-A40C-4F41-BD00-6B7DB6320AA2}"/>
                  </a:ext>
                </a:extLst>
              </p:cNvPr>
              <p:cNvCxnSpPr>
                <a:cxnSpLocks/>
                <a:stCxn id="63" idx="2"/>
                <a:endCxn id="64" idx="0"/>
              </p:cNvCxnSpPr>
              <p:nvPr/>
            </p:nvCxnSpPr>
            <p:spPr>
              <a:xfrm>
                <a:off x="10270979" y="8636760"/>
                <a:ext cx="3023" cy="26783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Gerade Verbindung mit Pfeil 137">
                <a:extLst>
                  <a:ext uri="{FF2B5EF4-FFF2-40B4-BE49-F238E27FC236}">
                    <a16:creationId xmlns:a16="http://schemas.microsoft.com/office/drawing/2014/main" id="{001209CA-3D21-4592-A8CF-D7FD04C0BF11}"/>
                  </a:ext>
                </a:extLst>
              </p:cNvPr>
              <p:cNvCxnSpPr>
                <a:cxnSpLocks/>
                <a:stCxn id="72" idx="3"/>
                <a:endCxn id="73" idx="1"/>
              </p:cNvCxnSpPr>
              <p:nvPr/>
            </p:nvCxnSpPr>
            <p:spPr>
              <a:xfrm>
                <a:off x="10846763" y="11189028"/>
                <a:ext cx="339054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Gerade Verbindung mit Pfeil 138">
                <a:extLst>
                  <a:ext uri="{FF2B5EF4-FFF2-40B4-BE49-F238E27FC236}">
                    <a16:creationId xmlns:a16="http://schemas.microsoft.com/office/drawing/2014/main" id="{97141A2C-B5BD-4D9E-80EA-B0F0AB26E7F2}"/>
                  </a:ext>
                </a:extLst>
              </p:cNvPr>
              <p:cNvCxnSpPr>
                <a:cxnSpLocks/>
                <a:stCxn id="71" idx="0"/>
                <a:endCxn id="72" idx="2"/>
              </p:cNvCxnSpPr>
              <p:nvPr/>
            </p:nvCxnSpPr>
            <p:spPr>
              <a:xfrm flipV="1">
                <a:off x="10245150" y="11577538"/>
                <a:ext cx="0" cy="26249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Gerade Verbindung mit Pfeil 139">
                <a:extLst>
                  <a:ext uri="{FF2B5EF4-FFF2-40B4-BE49-F238E27FC236}">
                    <a16:creationId xmlns:a16="http://schemas.microsoft.com/office/drawing/2014/main" id="{638523EE-D590-4219-A9A0-7A6B0A7EDB61}"/>
                  </a:ext>
                </a:extLst>
              </p:cNvPr>
              <p:cNvCxnSpPr>
                <a:cxnSpLocks/>
                <a:stCxn id="66" idx="2"/>
                <a:endCxn id="68" idx="0"/>
              </p:cNvCxnSpPr>
              <p:nvPr/>
            </p:nvCxnSpPr>
            <p:spPr>
              <a:xfrm>
                <a:off x="11782043" y="9615455"/>
                <a:ext cx="5388" cy="310008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Gerade Verbindung mit Pfeil 148">
                <a:extLst>
                  <a:ext uri="{FF2B5EF4-FFF2-40B4-BE49-F238E27FC236}">
                    <a16:creationId xmlns:a16="http://schemas.microsoft.com/office/drawing/2014/main" id="{FE71B68A-6902-40C3-A6D6-906CED38F986}"/>
                  </a:ext>
                </a:extLst>
              </p:cNvPr>
              <p:cNvCxnSpPr>
                <a:cxnSpLocks/>
                <a:stCxn id="73" idx="0"/>
                <a:endCxn id="68" idx="2"/>
              </p:cNvCxnSpPr>
              <p:nvPr/>
            </p:nvCxnSpPr>
            <p:spPr>
              <a:xfrm flipV="1">
                <a:off x="11787431" y="10570159"/>
                <a:ext cx="0" cy="296521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8" name="Textfeld 197">
                <a:extLst>
                  <a:ext uri="{FF2B5EF4-FFF2-40B4-BE49-F238E27FC236}">
                    <a16:creationId xmlns:a16="http://schemas.microsoft.com/office/drawing/2014/main" id="{26B7DC6D-1031-4291-A6E5-CF50E52840FC}"/>
                  </a:ext>
                </a:extLst>
              </p:cNvPr>
              <p:cNvSpPr txBox="1"/>
              <p:nvPr/>
            </p:nvSpPr>
            <p:spPr>
              <a:xfrm>
                <a:off x="7719082" y="13183740"/>
                <a:ext cx="517582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tage 4 – Building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e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ta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rices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and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mparative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alyses</a:t>
                </a:r>
                <a:b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tage 5 – Statistical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valuation</a:t>
                </a:r>
                <a:endParaRPr lang="de-CH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Gruppieren 4">
              <a:extLst>
                <a:ext uri="{FF2B5EF4-FFF2-40B4-BE49-F238E27FC236}">
                  <a16:creationId xmlns:a16="http://schemas.microsoft.com/office/drawing/2014/main" id="{47449E45-CB08-4732-B75F-BF9B10A44F52}"/>
                </a:ext>
              </a:extLst>
            </p:cNvPr>
            <p:cNvGrpSpPr/>
            <p:nvPr/>
          </p:nvGrpSpPr>
          <p:grpSpPr>
            <a:xfrm>
              <a:off x="2217950" y="15172237"/>
              <a:ext cx="10683449" cy="1809891"/>
              <a:chOff x="783205" y="12821203"/>
              <a:chExt cx="11454665" cy="1809891"/>
            </a:xfrm>
          </p:grpSpPr>
          <p:sp>
            <p:nvSpPr>
              <p:cNvPr id="2" name="Textfeld 1">
                <a:extLst>
                  <a:ext uri="{FF2B5EF4-FFF2-40B4-BE49-F238E27FC236}">
                    <a16:creationId xmlns:a16="http://schemas.microsoft.com/office/drawing/2014/main" id="{6391BEAD-A39D-4380-94E7-141581CAF1A0}"/>
                  </a:ext>
                </a:extLst>
              </p:cNvPr>
              <p:cNvSpPr txBox="1"/>
              <p:nvPr/>
            </p:nvSpPr>
            <p:spPr>
              <a:xfrm>
                <a:off x="4228564" y="14323317"/>
                <a:ext cx="45903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tage 6 –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flection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and review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f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e</a:t>
                </a:r>
                <a:r>
                  <a:rPr lang="de-CH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thodology</a:t>
                </a:r>
                <a:endParaRPr lang="de-CH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Geschweifte Klammer rechts 3">
                <a:extLst>
                  <a:ext uri="{FF2B5EF4-FFF2-40B4-BE49-F238E27FC236}">
                    <a16:creationId xmlns:a16="http://schemas.microsoft.com/office/drawing/2014/main" id="{E977EE98-E9BD-491C-A95C-A8FC58961712}"/>
                  </a:ext>
                </a:extLst>
              </p:cNvPr>
              <p:cNvSpPr/>
              <p:nvPr/>
            </p:nvSpPr>
            <p:spPr>
              <a:xfrm rot="5400000">
                <a:off x="6228672" y="7375736"/>
                <a:ext cx="563731" cy="11454665"/>
              </a:xfrm>
              <a:prstGeom prst="rightBrace">
                <a:avLst>
                  <a:gd name="adj1" fmla="val 54003"/>
                  <a:gd name="adj2" fmla="val 50000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CH"/>
              </a:p>
            </p:txBody>
          </p:sp>
        </p:grpSp>
        <p:sp>
          <p:nvSpPr>
            <p:cNvPr id="112" name="AutoShape 64">
              <a:extLst>
                <a:ext uri="{FF2B5EF4-FFF2-40B4-BE49-F238E27FC236}">
                  <a16:creationId xmlns:a16="http://schemas.microsoft.com/office/drawing/2014/main" id="{4A2F4B91-4221-4B09-AB62-3768E205F8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58059" y="15897354"/>
              <a:ext cx="1203227" cy="710269"/>
            </a:xfrm>
            <a:prstGeom prst="flowChartProcess">
              <a:avLst/>
            </a:prstGeom>
            <a:noFill/>
            <a:ln w="12700">
              <a:solidFill>
                <a:srgbClr val="1F3763"/>
              </a:solidFill>
              <a:miter lim="800000"/>
              <a:headEnd/>
              <a:tailEnd/>
            </a:ln>
          </p:spPr>
          <p:txBody>
            <a:bodyPr vert="horz" wrap="square" lIns="34892" tIns="34892" rIns="34892" bIns="34892" numCol="1" anchor="ctr" anchorCtr="0" compatLnSpc="1">
              <a:prstTxWarp prst="textNoShape">
                <a:avLst/>
              </a:prstTxWarp>
            </a:bodyPr>
            <a:lstStyle/>
            <a:p>
              <a:pPr algn="ctr" defTabSz="886236" eaLnBrk="0" fontAlgn="base" hangingPunct="0"/>
              <a:r>
                <a:rPr lang="en-GB" altLang="de-DE" sz="107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6.0</a:t>
              </a:r>
            </a:p>
            <a:p>
              <a:pPr algn="ctr" defTabSz="886236" eaLnBrk="0" fontAlgn="base" hangingPunct="0"/>
              <a:r>
                <a:rPr lang="en-GB" altLang="de-DE" sz="107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Reflection </a:t>
              </a:r>
              <a:br>
                <a:rPr lang="en-GB" altLang="de-DE" sz="107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</a:br>
              <a:r>
                <a:rPr lang="en-GB" altLang="de-DE" sz="107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nd review</a:t>
              </a:r>
            </a:p>
          </p:txBody>
        </p:sp>
      </p:grpSp>
      <p:sp>
        <p:nvSpPr>
          <p:cNvPr id="117" name="Textfeld 116">
            <a:extLst>
              <a:ext uri="{FF2B5EF4-FFF2-40B4-BE49-F238E27FC236}">
                <a16:creationId xmlns:a16="http://schemas.microsoft.com/office/drawing/2014/main" id="{2E99E5B4-9D2C-4278-86CE-12CBBBE1EF0A}"/>
              </a:ext>
            </a:extLst>
          </p:cNvPr>
          <p:cNvSpPr txBox="1"/>
          <p:nvPr/>
        </p:nvSpPr>
        <p:spPr>
          <a:xfrm>
            <a:off x="1378272" y="18297502"/>
            <a:ext cx="12362805" cy="17715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600"/>
              </a:spcAft>
            </a:pPr>
            <a:r>
              <a:rPr lang="en-GB" sz="1400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4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terial</a:t>
            </a:r>
            <a:endParaRPr lang="en-GB" sz="1400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600"/>
              </a:spcAft>
            </a:pPr>
            <a:r>
              <a:rPr lang="en-GB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systematic</a:t>
            </a:r>
            <a:r>
              <a:rPr lang="en-GB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ethodology to assess the identity of plants in historical texts: A case study based on the Byzantine pharmacy text John the Physician’s Therapeutics</a:t>
            </a:r>
            <a:endParaRPr lang="en-GB" sz="1400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600"/>
              </a:spcAft>
            </a:pPr>
            <a:r>
              <a:rPr lang="en-GB" sz="14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July</a:t>
            </a:r>
            <a:r>
              <a:rPr lang="en-GB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3 </a:t>
            </a:r>
            <a:endParaRPr lang="en-GB" sz="140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600"/>
              </a:spcAft>
            </a:pPr>
            <a:r>
              <a:rPr lang="en-GB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reas Lardos, Kristina Patmore, Robert Allkin, Rebecca Lazarou, Mark Nesbitt, Andrew C. Scott, Barbara Zipser</a:t>
            </a:r>
            <a:r>
              <a:rPr lang="en-GB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de-CH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600"/>
              </a:spcAft>
            </a:pPr>
            <a:r>
              <a:rPr lang="en-GB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ing author: Andreas Lardos, E-mail address: andreas.lardos@zhaw.ch; Tel.: +41 58 934 50 00</a:t>
            </a:r>
            <a:endParaRPr lang="de-CH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9051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82</Words>
  <Application>Microsoft Office PowerPoint</Application>
  <PresentationFormat>Benutzerdefiniert</PresentationFormat>
  <Paragraphs>9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ZHA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ardos Andreas (lard)</dc:creator>
  <cp:lastModifiedBy>Lardos Andreas (lard)</cp:lastModifiedBy>
  <cp:revision>59</cp:revision>
  <dcterms:created xsi:type="dcterms:W3CDTF">2023-01-04T08:53:19Z</dcterms:created>
  <dcterms:modified xsi:type="dcterms:W3CDTF">2023-12-16T18:18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10d9bad3-6dac-4e9a-89a3-89f3b8d247b2_Enabled">
    <vt:lpwstr>true</vt:lpwstr>
  </property>
  <property fmtid="{D5CDD505-2E9C-101B-9397-08002B2CF9AE}" pid="3" name="MSIP_Label_10d9bad3-6dac-4e9a-89a3-89f3b8d247b2_SetDate">
    <vt:lpwstr>2023-01-04T08:53:19Z</vt:lpwstr>
  </property>
  <property fmtid="{D5CDD505-2E9C-101B-9397-08002B2CF9AE}" pid="4" name="MSIP_Label_10d9bad3-6dac-4e9a-89a3-89f3b8d247b2_Method">
    <vt:lpwstr>Standard</vt:lpwstr>
  </property>
  <property fmtid="{D5CDD505-2E9C-101B-9397-08002B2CF9AE}" pid="5" name="MSIP_Label_10d9bad3-6dac-4e9a-89a3-89f3b8d247b2_Name">
    <vt:lpwstr>10d9bad3-6dac-4e9a-89a3-89f3b8d247b2</vt:lpwstr>
  </property>
  <property fmtid="{D5CDD505-2E9C-101B-9397-08002B2CF9AE}" pid="6" name="MSIP_Label_10d9bad3-6dac-4e9a-89a3-89f3b8d247b2_SiteId">
    <vt:lpwstr>5d1a9f9d-201f-4a10-b983-451cf65cbc1e</vt:lpwstr>
  </property>
  <property fmtid="{D5CDD505-2E9C-101B-9397-08002B2CF9AE}" pid="7" name="MSIP_Label_10d9bad3-6dac-4e9a-89a3-89f3b8d247b2_ActionId">
    <vt:lpwstr>0e134589-59fe-4711-af04-fc5b46a6e3d8</vt:lpwstr>
  </property>
  <property fmtid="{D5CDD505-2E9C-101B-9397-08002B2CF9AE}" pid="8" name="MSIP_Label_10d9bad3-6dac-4e9a-89a3-89f3b8d247b2_ContentBits">
    <vt:lpwstr>0</vt:lpwstr>
  </property>
</Properties>
</file>